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E8CB"/>
    <a:srgbClr val="F3E9DC"/>
    <a:srgbClr val="FFC000"/>
    <a:srgbClr val="F4B3FD"/>
    <a:srgbClr val="6481DF"/>
    <a:srgbClr val="F1B0F7"/>
    <a:srgbClr val="987ACF"/>
    <a:srgbClr val="C873CE"/>
    <a:srgbClr val="6E3BC4"/>
    <a:srgbClr val="DAA0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EC7BD48-4D9B-CE41-B109-7AAD47475BA8}" v="2" dt="2024-07-23T02:09:34.02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68D230F3-CF80-4859-8CE7-A43EE81993B5}" styleName="Light Style 1 - Acc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C4B1156A-380E-4F78-BDF5-A606A8083BF9}" styleName="Medium Style 4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4"/>
              </a:solidFill>
            </a:ln>
          </a:top>
        </a:tcBdr>
        <a:fill>
          <a:solidFill>
            <a:schemeClr val="accent4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4">
              <a:tint val="20000"/>
            </a:schemeClr>
          </a:solidFill>
        </a:fill>
      </a:tcStyle>
    </a:firstRow>
  </a:tblStyle>
  <a:tblStyle styleId="{8A107856-5554-42FB-B03E-39F5DBC370BA}" styleName="Medium Style 4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2"/>
              </a:solidFill>
            </a:ln>
          </a:top>
        </a:tcBdr>
        <a:fill>
          <a:solidFill>
            <a:schemeClr val="accent2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2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094"/>
    <p:restoredTop sz="94601"/>
  </p:normalViewPr>
  <p:slideViewPr>
    <p:cSldViewPr snapToGrid="0" snapToObjects="1">
      <p:cViewPr>
        <p:scale>
          <a:sx n="129" d="100"/>
          <a:sy n="129" d="100"/>
        </p:scale>
        <p:origin x="1512" y="-35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1C825C51-D024-134C-8923-28664422E62F}" type="doc">
      <dgm:prSet loTypeId="urn:microsoft.com/office/officeart/2005/8/layout/process2" loCatId="" qsTypeId="urn:microsoft.com/office/officeart/2005/8/quickstyle/simple1" qsCatId="simple" csTypeId="urn:microsoft.com/office/officeart/2005/8/colors/colorful5" csCatId="colorful" phldr="1"/>
      <dgm:spPr/>
    </dgm:pt>
    <dgm:pt modelId="{80E86576-9E9B-D144-9679-436011F83C87}">
      <dgm:prSet phldrT="[Text]" custT="1"/>
      <dgm:spPr>
        <a:solidFill>
          <a:srgbClr val="009C41">
            <a:alpha val="90196"/>
          </a:srgbClr>
        </a:solidFill>
      </dgm:spPr>
      <dgm:t>
        <a:bodyPr/>
        <a:lstStyle/>
        <a:p>
          <a:pPr algn="ctr"/>
          <a:r>
            <a:rPr lang="en-US" sz="1200" b="1" u="sng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Indications</a:t>
          </a:r>
        </a:p>
        <a:p>
          <a:pPr algn="l"/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HIV (-) and anal/vaginal sex in the past 6 months (or IVDU w/ shared equipment) </a:t>
          </a:r>
          <a:r>
            <a:rPr lang="en-US" sz="1100" u="sng" dirty="0">
              <a:latin typeface="Arial" panose="020B0604020202020204" pitchFamily="34" charset="0"/>
              <a:cs typeface="Arial" panose="020B0604020202020204" pitchFamily="34" charset="0"/>
            </a:rPr>
            <a:t>AND</a:t>
          </a:r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:</a:t>
          </a:r>
        </a:p>
        <a:p>
          <a:pPr algn="l"/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1) sexual partner with HIV (especially if unknown or detectable viral load), </a:t>
          </a:r>
          <a:r>
            <a:rPr lang="en-US" sz="1100" u="sng" dirty="0">
              <a:latin typeface="Arial" panose="020B0604020202020204" pitchFamily="34" charset="0"/>
              <a:cs typeface="Arial" panose="020B0604020202020204" pitchFamily="34" charset="0"/>
            </a:rPr>
            <a:t>OR</a:t>
          </a:r>
          <a:endParaRPr lang="en-US" sz="1100" dirty="0">
            <a:latin typeface="Arial" panose="020B0604020202020204" pitchFamily="34" charset="0"/>
            <a:cs typeface="Arial" panose="020B0604020202020204" pitchFamily="34" charset="0"/>
          </a:endParaRPr>
        </a:p>
        <a:p>
          <a:pPr algn="l"/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2) Inconsistent condom use, </a:t>
          </a:r>
          <a:r>
            <a:rPr lang="en-US" sz="1100" u="sng" dirty="0">
              <a:latin typeface="Arial" panose="020B0604020202020204" pitchFamily="34" charset="0"/>
              <a:cs typeface="Arial" panose="020B0604020202020204" pitchFamily="34" charset="0"/>
            </a:rPr>
            <a:t>OR</a:t>
          </a:r>
          <a:endParaRPr lang="en-US" sz="1100" dirty="0">
            <a:latin typeface="Arial" panose="020B0604020202020204" pitchFamily="34" charset="0"/>
            <a:cs typeface="Arial" panose="020B0604020202020204" pitchFamily="34" charset="0"/>
          </a:endParaRPr>
        </a:p>
        <a:p>
          <a:pPr algn="l"/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3) STI dx in the past 6 months</a:t>
          </a:r>
        </a:p>
      </dgm:t>
    </dgm:pt>
    <dgm:pt modelId="{5BFD46DA-17E6-984C-80A2-12EAFBE3C1E9}" type="parTrans" cxnId="{D89B983D-20D3-A24D-84C3-C667083ABFC8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EBD84B9-A25C-8742-A1E8-C57577EF858A}" type="sibTrans" cxnId="{D89B983D-20D3-A24D-84C3-C667083ABFC8}">
      <dgm:prSet/>
      <dgm:spPr>
        <a:solidFill>
          <a:srgbClr val="33A655"/>
        </a:solidFill>
      </dgm:spPr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CC98416-68D1-1A4C-8047-117AFD7110FD}">
      <dgm:prSet phldrT="[Text]" custT="1"/>
      <dgm:spPr>
        <a:solidFill>
          <a:srgbClr val="4C6BD7">
            <a:alpha val="85882"/>
          </a:srgbClr>
        </a:solidFill>
      </dgm:spPr>
      <dgm:t>
        <a:bodyPr/>
        <a:lstStyle/>
        <a:p>
          <a:pPr algn="ctr"/>
          <a:r>
            <a:rPr lang="en-US" sz="1200" b="1" u="sng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Baseline labs</a:t>
          </a:r>
        </a:p>
        <a:p>
          <a:pPr algn="l"/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HIV Ab/Ag*, HBsAb, HBcAb, HBsAg, HCV Ab reflex to VL, BMP, syphilis IgG/IgM, Chlamydia/gonorrhea (all pertinent sites), BhCG</a:t>
          </a:r>
        </a:p>
        <a:p>
          <a:pPr algn="l"/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*If signs of acute HIV or high-risk exposure &lt;4 weeks, send HIV RNA PCR</a:t>
          </a:r>
        </a:p>
      </dgm:t>
    </dgm:pt>
    <dgm:pt modelId="{4C600264-E46F-CF44-A658-63F3072B93DB}" type="parTrans" cxnId="{3B353355-DE5B-C440-9E63-49CB249DDBC0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E2472FE-7E4E-B646-A24F-005737844C35}" type="sibTrans" cxnId="{3B353355-DE5B-C440-9E63-49CB249DDBC0}">
      <dgm:prSet/>
      <dgm:spPr>
        <a:solidFill>
          <a:srgbClr val="6481DE"/>
        </a:solidFill>
      </dgm:spPr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A43393C-838B-6346-BC8E-9E7C84E67C95}">
      <dgm:prSet phldrT="[Text]" custT="1"/>
      <dgm:spPr>
        <a:solidFill>
          <a:srgbClr val="987ACF"/>
        </a:solidFill>
      </dgm:spPr>
      <dgm:t>
        <a:bodyPr/>
        <a:lstStyle/>
        <a:p>
          <a:pPr algn="ctr"/>
          <a:r>
            <a:rPr lang="en-US" sz="1200" b="1" u="sng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rescription</a:t>
          </a:r>
        </a:p>
        <a:p>
          <a:pPr algn="l"/>
          <a:r>
            <a:rPr lang="en-US" sz="1100" b="1" u="sng" dirty="0">
              <a:latin typeface="Arial" panose="020B0604020202020204" pitchFamily="34" charset="0"/>
              <a:cs typeface="Arial" panose="020B0604020202020204" pitchFamily="34" charset="0"/>
            </a:rPr>
            <a:t>Truvada</a:t>
          </a:r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: TDF/FTC; PO QD q3M;                   for all patients (sexual risk and IVDU)</a:t>
          </a:r>
        </a:p>
        <a:p>
          <a:pPr algn="l"/>
          <a:r>
            <a:rPr lang="en-US" sz="1100" b="1" u="sng" dirty="0">
              <a:latin typeface="Arial" panose="020B0604020202020204" pitchFamily="34" charset="0"/>
              <a:cs typeface="Arial" panose="020B0604020202020204" pitchFamily="34" charset="0"/>
            </a:rPr>
            <a:t>Descovy</a:t>
          </a:r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: TAF/FTC; PO QD q3M;                   for MSM and trans women</a:t>
          </a:r>
        </a:p>
        <a:p>
          <a:pPr algn="l"/>
          <a:r>
            <a:rPr lang="en-US" sz="1100" b="1" u="sng" dirty="0">
              <a:latin typeface="Arial" panose="020B0604020202020204" pitchFamily="34" charset="0"/>
              <a:cs typeface="Arial" panose="020B0604020202020204" pitchFamily="34" charset="0"/>
            </a:rPr>
            <a:t>Apretude</a:t>
          </a:r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: Cabotegravir; IM monthly (or PO QD) x2mo, then q2M; for high sexual risk pts</a:t>
          </a:r>
        </a:p>
      </dgm:t>
    </dgm:pt>
    <dgm:pt modelId="{70711B81-C74A-9848-B80C-312E3E256444}" type="parTrans" cxnId="{D4CAA2DB-4DED-A347-927F-56B6BF2045F1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C557C1B-7087-7D4D-8294-088077A627EC}" type="sibTrans" cxnId="{D4CAA2DB-4DED-A347-927F-56B6BF2045F1}">
      <dgm:prSet/>
      <dgm:spPr>
        <a:solidFill>
          <a:srgbClr val="987ACF"/>
        </a:solidFill>
      </dgm:spPr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563E351-C297-9D43-8B59-D91EB40EADCB}">
      <dgm:prSet phldrT="[Text]" custT="1"/>
      <dgm:spPr>
        <a:solidFill>
          <a:srgbClr val="C873CE">
            <a:alpha val="68235"/>
          </a:srgbClr>
        </a:solidFill>
      </dgm:spPr>
      <dgm:t>
        <a:bodyPr/>
        <a:lstStyle/>
        <a:p>
          <a:pPr algn="ctr"/>
          <a:r>
            <a:rPr lang="en-US" sz="1200" b="1" u="sng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Monitoring</a:t>
          </a:r>
        </a:p>
        <a:p>
          <a:pPr algn="l"/>
          <a:r>
            <a:rPr lang="en-US" sz="1100" b="1" u="sng" dirty="0">
              <a:latin typeface="Arial" panose="020B0604020202020204" pitchFamily="34" charset="0"/>
              <a:cs typeface="Arial" panose="020B0604020202020204" pitchFamily="34" charset="0"/>
            </a:rPr>
            <a:t>Q3M</a:t>
          </a:r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: HIV Ab/Ag, BMP (not for Apretude), full STI panel, BhCG, safe sex counseling, assess for acute HIV, med adherence, refill PO meds</a:t>
          </a:r>
        </a:p>
        <a:p>
          <a:pPr algn="l"/>
          <a:r>
            <a:rPr lang="en-US" sz="1100" b="1" u="sng" dirty="0">
              <a:latin typeface="Arial" panose="020B0604020202020204" pitchFamily="34" charset="0"/>
              <a:cs typeface="Arial" panose="020B0604020202020204" pitchFamily="34" charset="0"/>
            </a:rPr>
            <a:t>Q12M</a:t>
          </a:r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: UA*; weight, TG and cholesterol if on Descovy</a:t>
          </a:r>
        </a:p>
        <a:p>
          <a:pPr algn="l"/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*If CKD, perform UA q6M</a:t>
          </a:r>
        </a:p>
      </dgm:t>
    </dgm:pt>
    <dgm:pt modelId="{69530926-2816-6340-B49A-5940533E4514}" type="parTrans" cxnId="{419218A3-B133-DB43-AED7-6EA7672DDA6D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FDFDDF2-B8D7-A248-8504-82EDA8C055B2}" type="sibTrans" cxnId="{419218A3-B133-DB43-AED7-6EA7672DDA6D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C576711-8398-CD4E-AC72-3AAAF9344421}" type="pres">
      <dgm:prSet presAssocID="{1C825C51-D024-134C-8923-28664422E62F}" presName="linearFlow" presStyleCnt="0">
        <dgm:presLayoutVars>
          <dgm:resizeHandles val="exact"/>
        </dgm:presLayoutVars>
      </dgm:prSet>
      <dgm:spPr/>
    </dgm:pt>
    <dgm:pt modelId="{044D03A7-8538-8D41-800B-B7533C3D0672}" type="pres">
      <dgm:prSet presAssocID="{80E86576-9E9B-D144-9679-436011F83C87}" presName="node" presStyleLbl="node1" presStyleIdx="0" presStyleCnt="4" custScaleY="83634" custLinFactNeighborY="-1057">
        <dgm:presLayoutVars>
          <dgm:bulletEnabled val="1"/>
        </dgm:presLayoutVars>
      </dgm:prSet>
      <dgm:spPr/>
    </dgm:pt>
    <dgm:pt modelId="{BB1C220F-D8FF-5545-9851-5052FC693F51}" type="pres">
      <dgm:prSet presAssocID="{6EBD84B9-A25C-8742-A1E8-C57577EF858A}" presName="sibTrans" presStyleLbl="sibTrans2D1" presStyleIdx="0" presStyleCnt="3" custScaleX="116427" custScaleY="52149" custLinFactNeighborY="-24"/>
      <dgm:spPr/>
    </dgm:pt>
    <dgm:pt modelId="{233E5407-670C-304D-BE0B-62FF16E302DD}" type="pres">
      <dgm:prSet presAssocID="{6EBD84B9-A25C-8742-A1E8-C57577EF858A}" presName="connectorText" presStyleLbl="sibTrans2D1" presStyleIdx="0" presStyleCnt="3"/>
      <dgm:spPr/>
    </dgm:pt>
    <dgm:pt modelId="{521C8CDC-EFA8-4C48-9579-05AB32B7803C}" type="pres">
      <dgm:prSet presAssocID="{9CC98416-68D1-1A4C-8047-117AFD7110FD}" presName="node" presStyleLbl="node1" presStyleIdx="1" presStyleCnt="4" custScaleY="69297" custLinFactNeighborY="-18126">
        <dgm:presLayoutVars>
          <dgm:bulletEnabled val="1"/>
        </dgm:presLayoutVars>
      </dgm:prSet>
      <dgm:spPr/>
    </dgm:pt>
    <dgm:pt modelId="{7D524418-589F-DE4F-8AE5-DCE09D87AEAE}" type="pres">
      <dgm:prSet presAssocID="{AE2472FE-7E4E-B646-A24F-005737844C35}" presName="sibTrans" presStyleLbl="sibTrans2D1" presStyleIdx="1" presStyleCnt="3" custScaleX="120157" custScaleY="52149" custLinFactNeighborY="1376"/>
      <dgm:spPr/>
    </dgm:pt>
    <dgm:pt modelId="{3982474D-79EA-E24E-AA26-C33A3CBFB001}" type="pres">
      <dgm:prSet presAssocID="{AE2472FE-7E4E-B646-A24F-005737844C35}" presName="connectorText" presStyleLbl="sibTrans2D1" presStyleIdx="1" presStyleCnt="3"/>
      <dgm:spPr/>
    </dgm:pt>
    <dgm:pt modelId="{ABAEB778-F09B-CF42-A31F-D7DF11EA470C}" type="pres">
      <dgm:prSet presAssocID="{BA43393C-838B-6346-BC8E-9E7C84E67C95}" presName="node" presStyleLbl="node1" presStyleIdx="2" presStyleCnt="4" custScaleY="79301" custLinFactNeighborY="-33788">
        <dgm:presLayoutVars>
          <dgm:bulletEnabled val="1"/>
        </dgm:presLayoutVars>
      </dgm:prSet>
      <dgm:spPr/>
    </dgm:pt>
    <dgm:pt modelId="{B65DD47F-3843-AD4B-9591-E0A56EF99F1C}" type="pres">
      <dgm:prSet presAssocID="{2C557C1B-7087-7D4D-8294-088077A627EC}" presName="sibTrans" presStyleLbl="sibTrans2D1" presStyleIdx="2" presStyleCnt="3" custScaleX="114374" custScaleY="52149" custLinFactNeighborX="-1144" custLinFactNeighborY="1506"/>
      <dgm:spPr/>
    </dgm:pt>
    <dgm:pt modelId="{93DD4BF2-2A0B-0547-9C3F-03D761039FA0}" type="pres">
      <dgm:prSet presAssocID="{2C557C1B-7087-7D4D-8294-088077A627EC}" presName="connectorText" presStyleLbl="sibTrans2D1" presStyleIdx="2" presStyleCnt="3"/>
      <dgm:spPr/>
    </dgm:pt>
    <dgm:pt modelId="{4AC648E1-D5A9-1B4A-9B86-61BF13CB9762}" type="pres">
      <dgm:prSet presAssocID="{4563E351-C297-9D43-8B59-D91EB40EADCB}" presName="node" presStyleLbl="node1" presStyleIdx="3" presStyleCnt="4" custScaleY="77149" custLinFactNeighborX="0" custLinFactNeighborY="-45792">
        <dgm:presLayoutVars>
          <dgm:bulletEnabled val="1"/>
        </dgm:presLayoutVars>
      </dgm:prSet>
      <dgm:spPr/>
    </dgm:pt>
  </dgm:ptLst>
  <dgm:cxnLst>
    <dgm:cxn modelId="{79281A01-3295-B64A-893C-48A04E0722C1}" type="presOf" srcId="{1C825C51-D024-134C-8923-28664422E62F}" destId="{6C576711-8398-CD4E-AC72-3AAAF9344421}" srcOrd="0" destOrd="0" presId="urn:microsoft.com/office/officeart/2005/8/layout/process2"/>
    <dgm:cxn modelId="{92A00F1E-EFB7-F144-8A6B-D422A145F4C0}" type="presOf" srcId="{2C557C1B-7087-7D4D-8294-088077A627EC}" destId="{B65DD47F-3843-AD4B-9591-E0A56EF99F1C}" srcOrd="0" destOrd="0" presId="urn:microsoft.com/office/officeart/2005/8/layout/process2"/>
    <dgm:cxn modelId="{87CA4924-0C94-7844-9581-4F4E01EBDCAC}" type="presOf" srcId="{9CC98416-68D1-1A4C-8047-117AFD7110FD}" destId="{521C8CDC-EFA8-4C48-9579-05AB32B7803C}" srcOrd="0" destOrd="0" presId="urn:microsoft.com/office/officeart/2005/8/layout/process2"/>
    <dgm:cxn modelId="{D89B983D-20D3-A24D-84C3-C667083ABFC8}" srcId="{1C825C51-D024-134C-8923-28664422E62F}" destId="{80E86576-9E9B-D144-9679-436011F83C87}" srcOrd="0" destOrd="0" parTransId="{5BFD46DA-17E6-984C-80A2-12EAFBE3C1E9}" sibTransId="{6EBD84B9-A25C-8742-A1E8-C57577EF858A}"/>
    <dgm:cxn modelId="{306B363E-5112-2241-B8B0-F8B6788B1AAD}" type="presOf" srcId="{AE2472FE-7E4E-B646-A24F-005737844C35}" destId="{3982474D-79EA-E24E-AA26-C33A3CBFB001}" srcOrd="1" destOrd="0" presId="urn:microsoft.com/office/officeart/2005/8/layout/process2"/>
    <dgm:cxn modelId="{56A9C945-3171-4E4D-BCA2-96F32E388664}" type="presOf" srcId="{BA43393C-838B-6346-BC8E-9E7C84E67C95}" destId="{ABAEB778-F09B-CF42-A31F-D7DF11EA470C}" srcOrd="0" destOrd="0" presId="urn:microsoft.com/office/officeart/2005/8/layout/process2"/>
    <dgm:cxn modelId="{268F3D49-7563-6C4A-B0B7-A8808398B349}" type="presOf" srcId="{4563E351-C297-9D43-8B59-D91EB40EADCB}" destId="{4AC648E1-D5A9-1B4A-9B86-61BF13CB9762}" srcOrd="0" destOrd="0" presId="urn:microsoft.com/office/officeart/2005/8/layout/process2"/>
    <dgm:cxn modelId="{3B353355-DE5B-C440-9E63-49CB249DDBC0}" srcId="{1C825C51-D024-134C-8923-28664422E62F}" destId="{9CC98416-68D1-1A4C-8047-117AFD7110FD}" srcOrd="1" destOrd="0" parTransId="{4C600264-E46F-CF44-A658-63F3072B93DB}" sibTransId="{AE2472FE-7E4E-B646-A24F-005737844C35}"/>
    <dgm:cxn modelId="{F744F979-E4A8-7D48-86B9-A5E352BAC939}" type="presOf" srcId="{2C557C1B-7087-7D4D-8294-088077A627EC}" destId="{93DD4BF2-2A0B-0547-9C3F-03D761039FA0}" srcOrd="1" destOrd="0" presId="urn:microsoft.com/office/officeart/2005/8/layout/process2"/>
    <dgm:cxn modelId="{419218A3-B133-DB43-AED7-6EA7672DDA6D}" srcId="{1C825C51-D024-134C-8923-28664422E62F}" destId="{4563E351-C297-9D43-8B59-D91EB40EADCB}" srcOrd="3" destOrd="0" parTransId="{69530926-2816-6340-B49A-5940533E4514}" sibTransId="{DFDFDDF2-B8D7-A248-8504-82EDA8C055B2}"/>
    <dgm:cxn modelId="{610640BB-9694-0E49-97DE-8C08C40353E2}" type="presOf" srcId="{AE2472FE-7E4E-B646-A24F-005737844C35}" destId="{7D524418-589F-DE4F-8AE5-DCE09D87AEAE}" srcOrd="0" destOrd="0" presId="urn:microsoft.com/office/officeart/2005/8/layout/process2"/>
    <dgm:cxn modelId="{E81731CB-8EDD-3545-B6A3-064840B8CD7B}" type="presOf" srcId="{6EBD84B9-A25C-8742-A1E8-C57577EF858A}" destId="{233E5407-670C-304D-BE0B-62FF16E302DD}" srcOrd="1" destOrd="0" presId="urn:microsoft.com/office/officeart/2005/8/layout/process2"/>
    <dgm:cxn modelId="{0B41DECF-EECC-9C47-A2D0-C0DBCF465F47}" type="presOf" srcId="{80E86576-9E9B-D144-9679-436011F83C87}" destId="{044D03A7-8538-8D41-800B-B7533C3D0672}" srcOrd="0" destOrd="0" presId="urn:microsoft.com/office/officeart/2005/8/layout/process2"/>
    <dgm:cxn modelId="{6F192EDB-FFCB-D74E-A15B-6CAF2F231150}" type="presOf" srcId="{6EBD84B9-A25C-8742-A1E8-C57577EF858A}" destId="{BB1C220F-D8FF-5545-9851-5052FC693F51}" srcOrd="0" destOrd="0" presId="urn:microsoft.com/office/officeart/2005/8/layout/process2"/>
    <dgm:cxn modelId="{D4CAA2DB-4DED-A347-927F-56B6BF2045F1}" srcId="{1C825C51-D024-134C-8923-28664422E62F}" destId="{BA43393C-838B-6346-BC8E-9E7C84E67C95}" srcOrd="2" destOrd="0" parTransId="{70711B81-C74A-9848-B80C-312E3E256444}" sibTransId="{2C557C1B-7087-7D4D-8294-088077A627EC}"/>
    <dgm:cxn modelId="{454DB29D-98F8-0F4D-826F-5EE0D65225FC}" type="presParOf" srcId="{6C576711-8398-CD4E-AC72-3AAAF9344421}" destId="{044D03A7-8538-8D41-800B-B7533C3D0672}" srcOrd="0" destOrd="0" presId="urn:microsoft.com/office/officeart/2005/8/layout/process2"/>
    <dgm:cxn modelId="{85E1B3DB-419F-8448-921D-01B3C74E5D24}" type="presParOf" srcId="{6C576711-8398-CD4E-AC72-3AAAF9344421}" destId="{BB1C220F-D8FF-5545-9851-5052FC693F51}" srcOrd="1" destOrd="0" presId="urn:microsoft.com/office/officeart/2005/8/layout/process2"/>
    <dgm:cxn modelId="{B04A59FC-12FC-4A49-87F4-913DCAC1815D}" type="presParOf" srcId="{BB1C220F-D8FF-5545-9851-5052FC693F51}" destId="{233E5407-670C-304D-BE0B-62FF16E302DD}" srcOrd="0" destOrd="0" presId="urn:microsoft.com/office/officeart/2005/8/layout/process2"/>
    <dgm:cxn modelId="{657FE20C-6171-2F41-91FE-B589B73792E8}" type="presParOf" srcId="{6C576711-8398-CD4E-AC72-3AAAF9344421}" destId="{521C8CDC-EFA8-4C48-9579-05AB32B7803C}" srcOrd="2" destOrd="0" presId="urn:microsoft.com/office/officeart/2005/8/layout/process2"/>
    <dgm:cxn modelId="{CFF1A5DB-67DF-3541-97DE-12AF53F9547E}" type="presParOf" srcId="{6C576711-8398-CD4E-AC72-3AAAF9344421}" destId="{7D524418-589F-DE4F-8AE5-DCE09D87AEAE}" srcOrd="3" destOrd="0" presId="urn:microsoft.com/office/officeart/2005/8/layout/process2"/>
    <dgm:cxn modelId="{0B34C6BE-F70D-624A-9087-D75BDBCC3568}" type="presParOf" srcId="{7D524418-589F-DE4F-8AE5-DCE09D87AEAE}" destId="{3982474D-79EA-E24E-AA26-C33A3CBFB001}" srcOrd="0" destOrd="0" presId="urn:microsoft.com/office/officeart/2005/8/layout/process2"/>
    <dgm:cxn modelId="{B42909FD-445A-854F-AD4D-2B3AE7102C95}" type="presParOf" srcId="{6C576711-8398-CD4E-AC72-3AAAF9344421}" destId="{ABAEB778-F09B-CF42-A31F-D7DF11EA470C}" srcOrd="4" destOrd="0" presId="urn:microsoft.com/office/officeart/2005/8/layout/process2"/>
    <dgm:cxn modelId="{976AD5F6-C391-8842-8B6A-827A258730D2}" type="presParOf" srcId="{6C576711-8398-CD4E-AC72-3AAAF9344421}" destId="{B65DD47F-3843-AD4B-9591-E0A56EF99F1C}" srcOrd="5" destOrd="0" presId="urn:microsoft.com/office/officeart/2005/8/layout/process2"/>
    <dgm:cxn modelId="{5288BF50-9F9B-AC49-82FA-B653F97121A7}" type="presParOf" srcId="{B65DD47F-3843-AD4B-9591-E0A56EF99F1C}" destId="{93DD4BF2-2A0B-0547-9C3F-03D761039FA0}" srcOrd="0" destOrd="0" presId="urn:microsoft.com/office/officeart/2005/8/layout/process2"/>
    <dgm:cxn modelId="{5A4AC142-F37F-054C-B3B1-480393E93F80}" type="presParOf" srcId="{6C576711-8398-CD4E-AC72-3AAAF9344421}" destId="{4AC648E1-D5A9-1B4A-9B86-61BF13CB9762}" srcOrd="6" destOrd="0" presId="urn:microsoft.com/office/officeart/2005/8/layout/process2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044D03A7-8538-8D41-800B-B7533C3D0672}">
      <dsp:nvSpPr>
        <dsp:cNvPr id="0" name=""/>
        <dsp:cNvSpPr/>
      </dsp:nvSpPr>
      <dsp:spPr>
        <a:xfrm>
          <a:off x="0" y="0"/>
          <a:ext cx="3156596" cy="1549416"/>
        </a:xfrm>
        <a:prstGeom prst="roundRect">
          <a:avLst>
            <a:gd name="adj" fmla="val 10000"/>
          </a:avLst>
        </a:prstGeom>
        <a:solidFill>
          <a:srgbClr val="009C41">
            <a:alpha val="90196"/>
          </a:srgb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200" b="1" u="sng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Indications</a:t>
          </a:r>
        </a:p>
        <a:p>
          <a:pPr marL="0" lvl="0" indent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>
              <a:latin typeface="Arial" panose="020B0604020202020204" pitchFamily="34" charset="0"/>
              <a:cs typeface="Arial" panose="020B0604020202020204" pitchFamily="34" charset="0"/>
            </a:rPr>
            <a:t>HIV (-) and anal/vaginal sex in the past 6 months (or IVDU w/ shared equipment) </a:t>
          </a:r>
          <a:r>
            <a:rPr lang="en-US" sz="1100" u="sng" kern="1200" dirty="0">
              <a:latin typeface="Arial" panose="020B0604020202020204" pitchFamily="34" charset="0"/>
              <a:cs typeface="Arial" panose="020B0604020202020204" pitchFamily="34" charset="0"/>
            </a:rPr>
            <a:t>AND</a:t>
          </a:r>
          <a:r>
            <a:rPr lang="en-US" sz="1100" kern="1200" dirty="0">
              <a:latin typeface="Arial" panose="020B0604020202020204" pitchFamily="34" charset="0"/>
              <a:cs typeface="Arial" panose="020B0604020202020204" pitchFamily="34" charset="0"/>
            </a:rPr>
            <a:t>:</a:t>
          </a:r>
        </a:p>
        <a:p>
          <a:pPr marL="0" lvl="0" indent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>
              <a:latin typeface="Arial" panose="020B0604020202020204" pitchFamily="34" charset="0"/>
              <a:cs typeface="Arial" panose="020B0604020202020204" pitchFamily="34" charset="0"/>
            </a:rPr>
            <a:t>1) sexual partner with HIV (especially if unknown or detectable viral load), </a:t>
          </a:r>
          <a:r>
            <a:rPr lang="en-US" sz="1100" u="sng" kern="1200" dirty="0">
              <a:latin typeface="Arial" panose="020B0604020202020204" pitchFamily="34" charset="0"/>
              <a:cs typeface="Arial" panose="020B0604020202020204" pitchFamily="34" charset="0"/>
            </a:rPr>
            <a:t>OR</a:t>
          </a:r>
          <a:endParaRPr lang="en-US" sz="1100" kern="1200" dirty="0"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>
              <a:latin typeface="Arial" panose="020B0604020202020204" pitchFamily="34" charset="0"/>
              <a:cs typeface="Arial" panose="020B0604020202020204" pitchFamily="34" charset="0"/>
            </a:rPr>
            <a:t>2) Inconsistent condom use, </a:t>
          </a:r>
          <a:r>
            <a:rPr lang="en-US" sz="1100" u="sng" kern="1200" dirty="0">
              <a:latin typeface="Arial" panose="020B0604020202020204" pitchFamily="34" charset="0"/>
              <a:cs typeface="Arial" panose="020B0604020202020204" pitchFamily="34" charset="0"/>
            </a:rPr>
            <a:t>OR</a:t>
          </a:r>
          <a:endParaRPr lang="en-US" sz="1100" kern="1200" dirty="0"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>
              <a:latin typeface="Arial" panose="020B0604020202020204" pitchFamily="34" charset="0"/>
              <a:cs typeface="Arial" panose="020B0604020202020204" pitchFamily="34" charset="0"/>
            </a:rPr>
            <a:t>3) STI dx in the past 6 months</a:t>
          </a:r>
        </a:p>
      </dsp:txBody>
      <dsp:txXfrm>
        <a:off x="45381" y="45381"/>
        <a:ext cx="3065834" cy="1458654"/>
      </dsp:txXfrm>
    </dsp:sp>
    <dsp:sp modelId="{BB1C220F-D8FF-5545-9851-5052FC693F51}">
      <dsp:nvSpPr>
        <dsp:cNvPr id="0" name=""/>
        <dsp:cNvSpPr/>
      </dsp:nvSpPr>
      <dsp:spPr>
        <a:xfrm rot="5400000">
          <a:off x="1313118" y="1635524"/>
          <a:ext cx="530358" cy="434754"/>
        </a:xfrm>
        <a:prstGeom prst="rightArrow">
          <a:avLst>
            <a:gd name="adj1" fmla="val 60000"/>
            <a:gd name="adj2" fmla="val 50000"/>
          </a:avLst>
        </a:prstGeom>
        <a:solidFill>
          <a:srgbClr val="33A655"/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1333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3000" kern="1200">
            <a:latin typeface="Arial" panose="020B0604020202020204" pitchFamily="34" charset="0"/>
            <a:cs typeface="Arial" panose="020B0604020202020204" pitchFamily="34" charset="0"/>
          </a:endParaRPr>
        </a:p>
      </dsp:txBody>
      <dsp:txXfrm rot="-5400000">
        <a:off x="1447871" y="1587722"/>
        <a:ext cx="260852" cy="399932"/>
      </dsp:txXfrm>
    </dsp:sp>
    <dsp:sp modelId="{521C8CDC-EFA8-4C48-9579-05AB32B7803C}">
      <dsp:nvSpPr>
        <dsp:cNvPr id="0" name=""/>
        <dsp:cNvSpPr/>
      </dsp:nvSpPr>
      <dsp:spPr>
        <a:xfrm>
          <a:off x="0" y="2156787"/>
          <a:ext cx="3156596" cy="1283806"/>
        </a:xfrm>
        <a:prstGeom prst="roundRect">
          <a:avLst>
            <a:gd name="adj" fmla="val 10000"/>
          </a:avLst>
        </a:prstGeom>
        <a:solidFill>
          <a:srgbClr val="4C6BD7">
            <a:alpha val="85882"/>
          </a:srgb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200" b="1" u="sng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Baseline labs</a:t>
          </a:r>
        </a:p>
        <a:p>
          <a:pPr marL="0" lvl="0" indent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>
              <a:latin typeface="Arial" panose="020B0604020202020204" pitchFamily="34" charset="0"/>
              <a:cs typeface="Arial" panose="020B0604020202020204" pitchFamily="34" charset="0"/>
            </a:rPr>
            <a:t>HIV Ab/Ag*, HBsAb, HBcAb, HBsAg, HCV Ab reflex to VL, BMP, syphilis IgG/IgM, Chlamydia/gonorrhea (all pertinent sites), BhCG</a:t>
          </a:r>
        </a:p>
        <a:p>
          <a:pPr marL="0" lvl="0" indent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>
              <a:latin typeface="Arial" panose="020B0604020202020204" pitchFamily="34" charset="0"/>
              <a:cs typeface="Arial" panose="020B0604020202020204" pitchFamily="34" charset="0"/>
            </a:rPr>
            <a:t>*If signs of acute HIV or high-risk exposure &lt;4 weeks, send HIV RNA PCR</a:t>
          </a:r>
        </a:p>
      </dsp:txBody>
      <dsp:txXfrm>
        <a:off x="37601" y="2194388"/>
        <a:ext cx="3081394" cy="1208604"/>
      </dsp:txXfrm>
    </dsp:sp>
    <dsp:sp modelId="{7D524418-589F-DE4F-8AE5-DCE09D87AEAE}">
      <dsp:nvSpPr>
        <dsp:cNvPr id="0" name=""/>
        <dsp:cNvSpPr/>
      </dsp:nvSpPr>
      <dsp:spPr>
        <a:xfrm rot="5400000">
          <a:off x="1286267" y="3558742"/>
          <a:ext cx="584060" cy="434754"/>
        </a:xfrm>
        <a:prstGeom prst="rightArrow">
          <a:avLst>
            <a:gd name="adj1" fmla="val 60000"/>
            <a:gd name="adj2" fmla="val 50000"/>
          </a:avLst>
        </a:prstGeom>
        <a:solidFill>
          <a:srgbClr val="6481DE"/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1511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3400" kern="1200">
            <a:latin typeface="Arial" panose="020B0604020202020204" pitchFamily="34" charset="0"/>
            <a:cs typeface="Arial" panose="020B0604020202020204" pitchFamily="34" charset="0"/>
          </a:endParaRPr>
        </a:p>
      </dsp:txBody>
      <dsp:txXfrm rot="-5400000">
        <a:off x="1447871" y="3484089"/>
        <a:ext cx="260852" cy="453634"/>
      </dsp:txXfrm>
    </dsp:sp>
    <dsp:sp modelId="{ABAEB778-F09B-CF42-A31F-D7DF11EA470C}">
      <dsp:nvSpPr>
        <dsp:cNvPr id="0" name=""/>
        <dsp:cNvSpPr/>
      </dsp:nvSpPr>
      <dsp:spPr>
        <a:xfrm>
          <a:off x="0" y="4088702"/>
          <a:ext cx="3156596" cy="1469142"/>
        </a:xfrm>
        <a:prstGeom prst="roundRect">
          <a:avLst>
            <a:gd name="adj" fmla="val 10000"/>
          </a:avLst>
        </a:prstGeom>
        <a:solidFill>
          <a:srgbClr val="987ACF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200" b="1" u="sng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rescription</a:t>
          </a:r>
        </a:p>
        <a:p>
          <a:pPr marL="0" lvl="0" indent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b="1" u="sng" kern="1200" dirty="0">
              <a:latin typeface="Arial" panose="020B0604020202020204" pitchFamily="34" charset="0"/>
              <a:cs typeface="Arial" panose="020B0604020202020204" pitchFamily="34" charset="0"/>
            </a:rPr>
            <a:t>Truvada</a:t>
          </a:r>
          <a:r>
            <a:rPr lang="en-US" sz="1100" kern="1200" dirty="0">
              <a:latin typeface="Arial" panose="020B0604020202020204" pitchFamily="34" charset="0"/>
              <a:cs typeface="Arial" panose="020B0604020202020204" pitchFamily="34" charset="0"/>
            </a:rPr>
            <a:t>: TDF/FTC; PO QD q3M;                   for all patients (sexual risk and IVDU)</a:t>
          </a:r>
        </a:p>
        <a:p>
          <a:pPr marL="0" lvl="0" indent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b="1" u="sng" kern="1200" dirty="0">
              <a:latin typeface="Arial" panose="020B0604020202020204" pitchFamily="34" charset="0"/>
              <a:cs typeface="Arial" panose="020B0604020202020204" pitchFamily="34" charset="0"/>
            </a:rPr>
            <a:t>Descovy</a:t>
          </a:r>
          <a:r>
            <a:rPr lang="en-US" sz="1100" kern="1200" dirty="0">
              <a:latin typeface="Arial" panose="020B0604020202020204" pitchFamily="34" charset="0"/>
              <a:cs typeface="Arial" panose="020B0604020202020204" pitchFamily="34" charset="0"/>
            </a:rPr>
            <a:t>: TAF/FTC; PO QD q3M;                   for MSM and trans women</a:t>
          </a:r>
        </a:p>
        <a:p>
          <a:pPr marL="0" lvl="0" indent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b="1" u="sng" kern="1200" dirty="0">
              <a:latin typeface="Arial" panose="020B0604020202020204" pitchFamily="34" charset="0"/>
              <a:cs typeface="Arial" panose="020B0604020202020204" pitchFamily="34" charset="0"/>
            </a:rPr>
            <a:t>Apretude</a:t>
          </a:r>
          <a:r>
            <a:rPr lang="en-US" sz="1100" kern="1200" dirty="0">
              <a:latin typeface="Arial" panose="020B0604020202020204" pitchFamily="34" charset="0"/>
              <a:cs typeface="Arial" panose="020B0604020202020204" pitchFamily="34" charset="0"/>
            </a:rPr>
            <a:t>: Cabotegravir; IM monthly (or PO QD) x2mo, then q2M; for high sexual risk pts</a:t>
          </a:r>
        </a:p>
      </dsp:txBody>
      <dsp:txXfrm>
        <a:off x="43030" y="4131732"/>
        <a:ext cx="3070536" cy="1383082"/>
      </dsp:txXfrm>
    </dsp:sp>
    <dsp:sp modelId="{B65DD47F-3843-AD4B-9591-E0A56EF99F1C}">
      <dsp:nvSpPr>
        <dsp:cNvPr id="0" name=""/>
        <dsp:cNvSpPr/>
      </dsp:nvSpPr>
      <dsp:spPr>
        <a:xfrm rot="5400000">
          <a:off x="1266336" y="5709565"/>
          <a:ext cx="611687" cy="434754"/>
        </a:xfrm>
        <a:prstGeom prst="rightArrow">
          <a:avLst>
            <a:gd name="adj1" fmla="val 60000"/>
            <a:gd name="adj2" fmla="val 50000"/>
          </a:avLst>
        </a:prstGeom>
        <a:solidFill>
          <a:srgbClr val="987ACF"/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1600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3600" kern="1200">
            <a:latin typeface="Arial" panose="020B0604020202020204" pitchFamily="34" charset="0"/>
            <a:cs typeface="Arial" panose="020B0604020202020204" pitchFamily="34" charset="0"/>
          </a:endParaRPr>
        </a:p>
      </dsp:txBody>
      <dsp:txXfrm rot="-5400000">
        <a:off x="1441753" y="5621099"/>
        <a:ext cx="260852" cy="481261"/>
      </dsp:txXfrm>
    </dsp:sp>
    <dsp:sp modelId="{4AC648E1-D5A9-1B4A-9B86-61BF13CB9762}">
      <dsp:nvSpPr>
        <dsp:cNvPr id="0" name=""/>
        <dsp:cNvSpPr/>
      </dsp:nvSpPr>
      <dsp:spPr>
        <a:xfrm>
          <a:off x="0" y="6270929"/>
          <a:ext cx="3156596" cy="1429274"/>
        </a:xfrm>
        <a:prstGeom prst="roundRect">
          <a:avLst>
            <a:gd name="adj" fmla="val 10000"/>
          </a:avLst>
        </a:prstGeom>
        <a:solidFill>
          <a:srgbClr val="C873CE">
            <a:alpha val="68235"/>
          </a:srgb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200" b="1" u="sng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Monitoring</a:t>
          </a:r>
        </a:p>
        <a:p>
          <a:pPr marL="0" lvl="0" indent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b="1" u="sng" kern="1200" dirty="0">
              <a:latin typeface="Arial" panose="020B0604020202020204" pitchFamily="34" charset="0"/>
              <a:cs typeface="Arial" panose="020B0604020202020204" pitchFamily="34" charset="0"/>
            </a:rPr>
            <a:t>Q3M</a:t>
          </a:r>
          <a:r>
            <a:rPr lang="en-US" sz="1100" kern="1200" dirty="0">
              <a:latin typeface="Arial" panose="020B0604020202020204" pitchFamily="34" charset="0"/>
              <a:cs typeface="Arial" panose="020B0604020202020204" pitchFamily="34" charset="0"/>
            </a:rPr>
            <a:t>: HIV Ab/Ag, BMP (not for Apretude), full STI panel, BhCG, safe sex counseling, assess for acute HIV, med adherence, refill PO meds</a:t>
          </a:r>
        </a:p>
        <a:p>
          <a:pPr marL="0" lvl="0" indent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b="1" u="sng" kern="1200" dirty="0">
              <a:latin typeface="Arial" panose="020B0604020202020204" pitchFamily="34" charset="0"/>
              <a:cs typeface="Arial" panose="020B0604020202020204" pitchFamily="34" charset="0"/>
            </a:rPr>
            <a:t>Q12M</a:t>
          </a:r>
          <a:r>
            <a:rPr lang="en-US" sz="1100" kern="1200" dirty="0">
              <a:latin typeface="Arial" panose="020B0604020202020204" pitchFamily="34" charset="0"/>
              <a:cs typeface="Arial" panose="020B0604020202020204" pitchFamily="34" charset="0"/>
            </a:rPr>
            <a:t>: UA*; weight, TG and cholesterol if on Descovy</a:t>
          </a:r>
        </a:p>
        <a:p>
          <a:pPr marL="0" lvl="0" indent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>
              <a:latin typeface="Arial" panose="020B0604020202020204" pitchFamily="34" charset="0"/>
              <a:cs typeface="Arial" panose="020B0604020202020204" pitchFamily="34" charset="0"/>
            </a:rPr>
            <a:t>*If CKD, perform UA q6M</a:t>
          </a:r>
        </a:p>
      </dsp:txBody>
      <dsp:txXfrm>
        <a:off x="41862" y="6312791"/>
        <a:ext cx="3072872" cy="1345550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rocess2">
  <dgm:title val=""/>
  <dgm:desc val=""/>
  <dgm:catLst>
    <dgm:cat type="process" pri="13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linearFlow">
    <dgm:varLst>
      <dgm:resizeHandles val="exact"/>
    </dgm:varLst>
    <dgm:alg type="lin">
      <dgm:param type="linDir" val="fromT"/>
    </dgm:alg>
    <dgm:shape xmlns:r="http://schemas.openxmlformats.org/officeDocument/2006/relationships" r:blip="">
      <dgm:adjLst/>
    </dgm:shape>
    <dgm:presOf/>
    <dgm:constrLst>
      <dgm:constr type="h" for="ch" ptType="node" refType="h"/>
      <dgm:constr type="h" for="ch" ptType="sibTrans" refType="h" refFor="ch" refPtType="node" fact="0.5"/>
      <dgm:constr type="w" for="ch" ptType="node" op="equ"/>
      <dgm:constr type="primFontSz" for="ch" ptType="node" op="equ" val="65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choose name="Name0">
          <dgm:if name="Name1" axis="root des" ptType="all node" func="maxDepth" op="gt" val="1">
            <dgm:alg type="tx">
              <dgm:param type="parTxLTRAlign" val="l"/>
              <dgm:param type="parTxRTLAlign" val="r"/>
              <dgm:param type="txAnchorVertCh" val="mid"/>
            </dgm:alg>
          </dgm:if>
          <dgm:else name="Name2">
            <dgm:alg type="tx"/>
          </dgm:else>
        </dgm:choose>
        <dgm:shape xmlns:r="http://schemas.openxmlformats.org/officeDocument/2006/relationships" type="roundRect" r:blip="">
          <dgm:adjLst>
            <dgm:adj idx="1" val="0.1"/>
          </dgm:adjLst>
        </dgm:shape>
        <dgm:presOf axis="desOrSelf" ptType="node"/>
        <dgm:constrLst>
          <dgm:constr type="w" refType="h" fact="1.8"/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primFontSz" val="18" fact="NaN" max="NaN"/>
          <dgm:rule type="w" val="NaN" fact="4" max="NaN"/>
          <dgm:rule type="primFontSz" val="5" fact="NaN" max="NaN"/>
        </dgm:ruleLst>
      </dgm:layoutNode>
      <dgm:forEach name="sibTransForEach" axis="followSib" ptType="sibTrans" cnt="1">
        <dgm:layoutNode name="sibTrans">
          <dgm:alg type="conn">
            <dgm:param type="begPts" val="auto"/>
            <dgm:param type="endPts" val="auto"/>
          </dgm:alg>
          <dgm:shape xmlns:r="http://schemas.openxmlformats.org/officeDocument/2006/relationships" type="conn" r:blip="">
            <dgm:adjLst/>
          </dgm:shape>
          <dgm:presOf axis="self"/>
          <dgm:constrLst>
            <dgm:constr type="w" refType="h" fact="0.9"/>
            <dgm:constr type="connDist"/>
            <dgm:constr type="wArH" refType="w" fact="0.5"/>
            <dgm:constr type="hArH" refType="w"/>
            <dgm:constr type="stemThick" refType="w" fact="0.6"/>
            <dgm:constr type="begPad" refType="connDist" fact="0.125"/>
            <dgm:constr type="endPad" refType="connDist" fact="0.125"/>
          </dgm:constrLst>
          <dgm:ruleLst/>
          <dgm:layoutNode name="connectorText">
            <dgm:alg type="tx">
              <dgm:param type="autoTxRot" val="upr"/>
            </dgm:alg>
            <dgm:shape xmlns:r="http://schemas.openxmlformats.org/officeDocument/2006/relationships" type="conn" r:blip="" hideGeom="1">
              <dgm:adjLst/>
            </dgm:shape>
            <dgm:presOf axis="self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103128-2A09-3F45-BE0C-B638DBD7C4D2}" type="datetimeFigureOut">
              <a:rPr lang="en-US" smtClean="0"/>
              <a:t>7/22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87FDAF-3243-9E48-B4BA-71967FA86D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8562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87FDAF-3243-9E48-B4BA-71967FA86D2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8361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FD580-4CDF-B748-932E-8D167EEBC0FB}" type="datetimeFigureOut">
              <a:rPr lang="en-US" smtClean="0"/>
              <a:t>7/2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75AF3-6515-8B42-8F05-330526BCE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380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FD580-4CDF-B748-932E-8D167EEBC0FB}" type="datetimeFigureOut">
              <a:rPr lang="en-US" smtClean="0"/>
              <a:t>7/2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75AF3-6515-8B42-8F05-330526BCE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1926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FD580-4CDF-B748-932E-8D167EEBC0FB}" type="datetimeFigureOut">
              <a:rPr lang="en-US" smtClean="0"/>
              <a:t>7/2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75AF3-6515-8B42-8F05-330526BCE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51896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FD580-4CDF-B748-932E-8D167EEBC0FB}" type="datetimeFigureOut">
              <a:rPr lang="en-US" smtClean="0"/>
              <a:t>7/2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75AF3-6515-8B42-8F05-330526BCE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96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FD580-4CDF-B748-932E-8D167EEBC0FB}" type="datetimeFigureOut">
              <a:rPr lang="en-US" smtClean="0"/>
              <a:t>7/2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75AF3-6515-8B42-8F05-330526BCE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9614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FD580-4CDF-B748-932E-8D167EEBC0FB}" type="datetimeFigureOut">
              <a:rPr lang="en-US" smtClean="0"/>
              <a:t>7/2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75AF3-6515-8B42-8F05-330526BCE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312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FD580-4CDF-B748-932E-8D167EEBC0FB}" type="datetimeFigureOut">
              <a:rPr lang="en-US" smtClean="0"/>
              <a:t>7/22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75AF3-6515-8B42-8F05-330526BCE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2170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FD580-4CDF-B748-932E-8D167EEBC0FB}" type="datetimeFigureOut">
              <a:rPr lang="en-US" smtClean="0"/>
              <a:t>7/22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75AF3-6515-8B42-8F05-330526BCE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8821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FD580-4CDF-B748-932E-8D167EEBC0FB}" type="datetimeFigureOut">
              <a:rPr lang="en-US" smtClean="0"/>
              <a:t>7/22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75AF3-6515-8B42-8F05-330526BCE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231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FD580-4CDF-B748-932E-8D167EEBC0FB}" type="datetimeFigureOut">
              <a:rPr lang="en-US" smtClean="0"/>
              <a:t>7/2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75AF3-6515-8B42-8F05-330526BCE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45510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FD580-4CDF-B748-932E-8D167EEBC0FB}" type="datetimeFigureOut">
              <a:rPr lang="en-US" smtClean="0"/>
              <a:t>7/2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75AF3-6515-8B42-8F05-330526BCE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6105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6FD580-4CDF-B748-932E-8D167EEBC0FB}" type="datetimeFigureOut">
              <a:rPr lang="en-US" smtClean="0"/>
              <a:t>7/2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175AF3-6515-8B42-8F05-330526BCE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97705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13" Type="http://schemas.openxmlformats.org/officeDocument/2006/relationships/image" Target="../media/image6.svg"/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12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9.svg"/><Relationship Id="rId1" Type="http://schemas.openxmlformats.org/officeDocument/2006/relationships/slideLayout" Target="../slideLayouts/slideLayout1.xml"/><Relationship Id="rId6" Type="http://schemas.openxmlformats.org/officeDocument/2006/relationships/diagramColors" Target="../diagrams/colors1.xml"/><Relationship Id="rId11" Type="http://schemas.openxmlformats.org/officeDocument/2006/relationships/image" Target="../media/image4.svg"/><Relationship Id="rId5" Type="http://schemas.openxmlformats.org/officeDocument/2006/relationships/diagramQuickStyle" Target="../diagrams/quickStyle1.xml"/><Relationship Id="rId15" Type="http://schemas.openxmlformats.org/officeDocument/2006/relationships/image" Target="../media/image8.png"/><Relationship Id="rId10" Type="http://schemas.openxmlformats.org/officeDocument/2006/relationships/image" Target="../media/image3.png"/><Relationship Id="rId4" Type="http://schemas.openxmlformats.org/officeDocument/2006/relationships/diagramLayout" Target="../diagrams/layout1.xml"/><Relationship Id="rId9" Type="http://schemas.openxmlformats.org/officeDocument/2006/relationships/image" Target="../media/image2.svg"/><Relationship Id="rId14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Diagram 9">
            <a:extLst>
              <a:ext uri="{FF2B5EF4-FFF2-40B4-BE49-F238E27FC236}">
                <a16:creationId xmlns:a16="http://schemas.microsoft.com/office/drawing/2014/main" id="{24660B9A-350F-4445-8EC4-8CDE7EBABEF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609819754"/>
              </p:ext>
            </p:extLst>
          </p:nvPr>
        </p:nvGraphicFramePr>
        <p:xfrm>
          <a:off x="4525703" y="986191"/>
          <a:ext cx="3156596" cy="851662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19708BD3-B5FC-6543-9A01-8B34626FF96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74819507"/>
              </p:ext>
            </p:extLst>
          </p:nvPr>
        </p:nvGraphicFramePr>
        <p:xfrm>
          <a:off x="159549" y="868070"/>
          <a:ext cx="4035024" cy="1584960"/>
        </p:xfrm>
        <a:graphic>
          <a:graphicData uri="http://schemas.openxmlformats.org/drawingml/2006/table">
            <a:tbl>
              <a:tblPr firstRow="1" bandRow="1">
                <a:tableStyleId>{69CF1AB2-1976-4502-BF36-3FF5EA218861}</a:tableStyleId>
              </a:tblPr>
              <a:tblGrid>
                <a:gridCol w="877618">
                  <a:extLst>
                    <a:ext uri="{9D8B030D-6E8A-4147-A177-3AD203B41FA5}">
                      <a16:colId xmlns:a16="http://schemas.microsoft.com/office/drawing/2014/main" val="724790259"/>
                    </a:ext>
                  </a:extLst>
                </a:gridCol>
                <a:gridCol w="3157406">
                  <a:extLst>
                    <a:ext uri="{9D8B030D-6E8A-4147-A177-3AD203B41FA5}">
                      <a16:colId xmlns:a16="http://schemas.microsoft.com/office/drawing/2014/main" val="307925455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000" b="0" dirty="0"/>
                        <a:t>Sex</a:t>
                      </a:r>
                      <a:endParaRPr lang="en-US" sz="10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9B9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b="0" dirty="0"/>
                        <a:t>Assigned at birth, depending on male or female phenotypes (anatomy, genitals, chromosomes)</a:t>
                      </a:r>
                      <a:endParaRPr lang="en-US" sz="10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1104">
                        <a:alpha val="46275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00914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00" dirty="0"/>
                        <a:t>Gender identity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9B94">
                        <a:alpha val="61176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One’s internal sense of being a man, a woman or somewhere in the spectrum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9B94">
                        <a:alpha val="61176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8313426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00" dirty="0"/>
                        <a:t>Gender expression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9B94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The way a person acts, dresses, speaks, and behaves (i.e., feminine, masculine, androgynous)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9B9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9264023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00" dirty="0"/>
                        <a:t>Sexual orientation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C2B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Sexual attraction/behaviors or emotional/romantic feelings; independent of gender identity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2110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C2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70055640"/>
                  </a:ext>
                </a:extLst>
              </a:tr>
            </a:tbl>
          </a:graphicData>
        </a:graphic>
      </p:graphicFrame>
      <p:graphicFrame>
        <p:nvGraphicFramePr>
          <p:cNvPr id="6" name="Table 6">
            <a:extLst>
              <a:ext uri="{FF2B5EF4-FFF2-40B4-BE49-F238E27FC236}">
                <a16:creationId xmlns:a16="http://schemas.microsoft.com/office/drawing/2014/main" id="{7EDACF3D-24CF-1C45-B78B-1EF1E7F2D85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1722890"/>
              </p:ext>
            </p:extLst>
          </p:nvPr>
        </p:nvGraphicFramePr>
        <p:xfrm>
          <a:off x="159549" y="2862234"/>
          <a:ext cx="4035021" cy="2621280"/>
        </p:xfrm>
        <a:graphic>
          <a:graphicData uri="http://schemas.openxmlformats.org/drawingml/2006/table">
            <a:tbl>
              <a:tblPr firstRow="1" bandRow="1">
                <a:tableStyleId>{8A107856-5554-42FB-B03E-39F5DBC370BA}</a:tableStyleId>
              </a:tblPr>
              <a:tblGrid>
                <a:gridCol w="818351">
                  <a:extLst>
                    <a:ext uri="{9D8B030D-6E8A-4147-A177-3AD203B41FA5}">
                      <a16:colId xmlns:a16="http://schemas.microsoft.com/office/drawing/2014/main" val="2947851064"/>
                    </a:ext>
                  </a:extLst>
                </a:gridCol>
                <a:gridCol w="3216670">
                  <a:extLst>
                    <a:ext uri="{9D8B030D-6E8A-4147-A177-3AD203B41FA5}">
                      <a16:colId xmlns:a16="http://schemas.microsoft.com/office/drawing/2014/main" val="62706386"/>
                    </a:ext>
                  </a:extLst>
                </a:gridCol>
              </a:tblGrid>
              <a:tr h="128096">
                <a:tc>
                  <a:txBody>
                    <a:bodyPr/>
                    <a:lstStyle/>
                    <a:p>
                      <a:r>
                        <a:rPr lang="en-US" sz="1000" b="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ermiss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b="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sk permission to discuss sexual history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6110946"/>
                  </a:ext>
                </a:extLst>
              </a:tr>
              <a:tr h="128096">
                <a:tc>
                  <a:txBody>
                    <a:bodyPr/>
                    <a:lstStyle/>
                    <a:p>
                      <a:r>
                        <a:rPr lang="en-US" sz="1000" b="0" dirty="0"/>
                        <a:t>Partners</a:t>
                      </a:r>
                      <a:endParaRPr lang="en-US" sz="10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b="0" dirty="0"/>
                        <a:t>Number, gender of partners, sexual orientation</a:t>
                      </a:r>
                      <a:endParaRPr lang="en-US" sz="10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31058899"/>
                  </a:ext>
                </a:extLst>
              </a:tr>
              <a:tr h="288216">
                <a:tc>
                  <a:txBody>
                    <a:bodyPr/>
                    <a:lstStyle/>
                    <a:p>
                      <a:r>
                        <a:rPr lang="en-US" sz="1000" dirty="0"/>
                        <a:t>Practices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Answer “who is putting what, where, when, and how”: types of sex, body parts used, substance use, kinks, lubricants, toys, sex work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8155895"/>
                  </a:ext>
                </a:extLst>
              </a:tr>
              <a:tr h="208156">
                <a:tc>
                  <a:txBody>
                    <a:bodyPr/>
                    <a:lstStyle/>
                    <a:p>
                      <a:r>
                        <a:rPr lang="en-US" sz="1000" dirty="0"/>
                        <a:t>Protection from STIs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Use of condoms or other barrier protection (including for oral sex) use and frequency of use, PrEP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14033451"/>
                  </a:ext>
                </a:extLst>
              </a:tr>
              <a:tr h="208156">
                <a:tc>
                  <a:txBody>
                    <a:bodyPr/>
                    <a:lstStyle/>
                    <a:p>
                      <a:r>
                        <a:rPr lang="en-US" sz="1000" dirty="0"/>
                        <a:t>Prior STIs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STI diagnoses and treatment, partner history of STI, interested in testing for STIs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5905847"/>
                  </a:ext>
                </a:extLst>
              </a:tr>
              <a:tr h="208156">
                <a:tc>
                  <a:txBody>
                    <a:bodyPr/>
                    <a:lstStyle/>
                    <a:p>
                      <a:r>
                        <a:rPr lang="en-US" sz="1000" dirty="0"/>
                        <a:t>Pleasure &amp; pain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Satisfaction or pain; problems with erection, ejaculation, lubrication, orgasm; history of sexual abuse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89454696"/>
                  </a:ext>
                </a:extLst>
              </a:tr>
              <a:tr h="194812">
                <a:tc>
                  <a:txBody>
                    <a:bodyPr/>
                    <a:lstStyle/>
                    <a:p>
                      <a:r>
                        <a:rPr lang="en-US" sz="1000" dirty="0"/>
                        <a:t>Pregnancy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Prevention or planning of pregnancy (ask about birth control)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7113490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ABB3B122-2606-0547-BD8D-1119C3A0EB84}"/>
              </a:ext>
            </a:extLst>
          </p:cNvPr>
          <p:cNvSpPr txBox="1"/>
          <p:nvPr/>
        </p:nvSpPr>
        <p:spPr>
          <a:xfrm>
            <a:off x="0" y="104172"/>
            <a:ext cx="77723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Helvetica" pitchFamily="2" charset="0"/>
                <a:cs typeface="Arial" panose="020B0604020202020204" pitchFamily="34" charset="0"/>
              </a:rPr>
              <a:t>Gender and sexual diverse (GSD) health </a:t>
            </a:r>
          </a:p>
        </p:txBody>
      </p:sp>
      <p:graphicFrame>
        <p:nvGraphicFramePr>
          <p:cNvPr id="13" name="Table 4">
            <a:extLst>
              <a:ext uri="{FF2B5EF4-FFF2-40B4-BE49-F238E27FC236}">
                <a16:creationId xmlns:a16="http://schemas.microsoft.com/office/drawing/2014/main" id="{40645CC7-6625-A347-A9D0-3BA083E660B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7405774"/>
              </p:ext>
            </p:extLst>
          </p:nvPr>
        </p:nvGraphicFramePr>
        <p:xfrm>
          <a:off x="159548" y="5884831"/>
          <a:ext cx="4035020" cy="2296520"/>
        </p:xfrm>
        <a:graphic>
          <a:graphicData uri="http://schemas.openxmlformats.org/drawingml/2006/table">
            <a:tbl>
              <a:tblPr firstRow="1" bandRow="1">
                <a:tableStyleId>{C4B1156A-380E-4F78-BDF5-A606A8083BF9}</a:tableStyleId>
              </a:tblPr>
              <a:tblGrid>
                <a:gridCol w="1046954">
                  <a:extLst>
                    <a:ext uri="{9D8B030D-6E8A-4147-A177-3AD203B41FA5}">
                      <a16:colId xmlns:a16="http://schemas.microsoft.com/office/drawing/2014/main" val="1718571615"/>
                    </a:ext>
                  </a:extLst>
                </a:gridCol>
                <a:gridCol w="2988066">
                  <a:extLst>
                    <a:ext uri="{9D8B030D-6E8A-4147-A177-3AD203B41FA5}">
                      <a16:colId xmlns:a16="http://schemas.microsoft.com/office/drawing/2014/main" val="1923830984"/>
                    </a:ext>
                  </a:extLst>
                </a:gridCol>
              </a:tblGrid>
              <a:tr h="214217">
                <a:tc>
                  <a:txBody>
                    <a:bodyPr/>
                    <a:lstStyle/>
                    <a:p>
                      <a:r>
                        <a:rPr lang="en-US" sz="1100" b="0" dirty="0"/>
                        <a:t>HIV Ag/Ab</a:t>
                      </a:r>
                    </a:p>
                  </a:txBody>
                  <a:tcPr marL="56968" marR="56968" marT="28484" marB="28484"/>
                </a:tc>
                <a:tc>
                  <a:txBody>
                    <a:bodyPr/>
                    <a:lstStyle/>
                    <a:p>
                      <a:r>
                        <a:rPr lang="en-US" sz="1100" b="0" dirty="0"/>
                        <a:t>All adults at least once (MSM at least q12mo)</a:t>
                      </a:r>
                    </a:p>
                  </a:txBody>
                  <a:tcPr marL="56968" marR="56968" marT="28484" marB="28484"/>
                </a:tc>
                <a:extLst>
                  <a:ext uri="{0D108BD9-81ED-4DB2-BD59-A6C34878D82A}">
                    <a16:rowId xmlns:a16="http://schemas.microsoft.com/office/drawing/2014/main" val="692595150"/>
                  </a:ext>
                </a:extLst>
              </a:tr>
              <a:tr h="220696">
                <a:tc>
                  <a:txBody>
                    <a:bodyPr/>
                    <a:lstStyle/>
                    <a:p>
                      <a:r>
                        <a:rPr lang="en-US" sz="1100" dirty="0"/>
                        <a:t>Syphilis IgG, IgM</a:t>
                      </a:r>
                    </a:p>
                  </a:txBody>
                  <a:tcPr marL="56968" marR="56968" marT="28484" marB="28484"/>
                </a:tc>
                <a:tc>
                  <a:txBody>
                    <a:bodyPr/>
                    <a:lstStyle/>
                    <a:p>
                      <a:r>
                        <a:rPr lang="en-US" sz="1100" b="0" dirty="0"/>
                        <a:t>MSM at least q12mo</a:t>
                      </a:r>
                    </a:p>
                  </a:txBody>
                  <a:tcPr marL="56968" marR="56968" marT="28484" marB="28484"/>
                </a:tc>
                <a:extLst>
                  <a:ext uri="{0D108BD9-81ED-4DB2-BD59-A6C34878D82A}">
                    <a16:rowId xmlns:a16="http://schemas.microsoft.com/office/drawing/2014/main" val="3382007712"/>
                  </a:ext>
                </a:extLst>
              </a:tr>
              <a:tr h="544182">
                <a:tc>
                  <a:txBody>
                    <a:bodyPr/>
                    <a:lstStyle/>
                    <a:p>
                      <a:r>
                        <a:rPr lang="en-US" sz="1100" dirty="0"/>
                        <a:t>Gonorrhea </a:t>
                      </a:r>
                    </a:p>
                    <a:p>
                      <a:r>
                        <a:rPr lang="en-US" sz="1100" dirty="0"/>
                        <a:t>and Chlamydia</a:t>
                      </a:r>
                    </a:p>
                    <a:p>
                      <a:endParaRPr lang="en-US" sz="1100" dirty="0"/>
                    </a:p>
                  </a:txBody>
                  <a:tcPr marL="56968" marR="56968" marT="28484" marB="28484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Rectal swab: If anal receptive sex</a:t>
                      </a:r>
                    </a:p>
                    <a:p>
                      <a:r>
                        <a:rPr lang="en-US" sz="1100" dirty="0"/>
                        <a:t>Pharyngeal swab: If oral receptive sex</a:t>
                      </a:r>
                    </a:p>
                    <a:p>
                      <a:pPr marL="0" marR="0" lvl="0" indent="0" algn="l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Urine: If anal/oral insertive or vaginal sex</a:t>
                      </a:r>
                    </a:p>
                    <a:p>
                      <a:pPr marL="0" marR="0" lvl="0" indent="0" algn="l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Vaginal self-swab: If vaginal sex (cis-women and trans men &lt;25y at least once)</a:t>
                      </a:r>
                    </a:p>
                    <a:p>
                      <a:pPr marL="0" marR="0" lvl="0" indent="0" algn="l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/>
                        <a:t>MSM at least q12mo</a:t>
                      </a:r>
                    </a:p>
                  </a:txBody>
                  <a:tcPr marL="56968" marR="56968" marT="28484" marB="28484"/>
                </a:tc>
                <a:extLst>
                  <a:ext uri="{0D108BD9-81ED-4DB2-BD59-A6C34878D82A}">
                    <a16:rowId xmlns:a16="http://schemas.microsoft.com/office/drawing/2014/main" val="853652088"/>
                  </a:ext>
                </a:extLst>
              </a:tr>
              <a:tr h="156595">
                <a:tc>
                  <a:txBody>
                    <a:bodyPr/>
                    <a:lstStyle/>
                    <a:p>
                      <a:r>
                        <a:rPr lang="en-US" sz="1100" dirty="0"/>
                        <a:t>HBsAb and HBsAg</a:t>
                      </a:r>
                    </a:p>
                  </a:txBody>
                  <a:tcPr marL="56968" marR="56968" marT="28484" marB="28484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All MSM, if non-immune, periodically thereafter until effective vaccination status</a:t>
                      </a:r>
                    </a:p>
                  </a:txBody>
                  <a:tcPr marL="56968" marR="56968" marT="28484" marB="28484"/>
                </a:tc>
                <a:extLst>
                  <a:ext uri="{0D108BD9-81ED-4DB2-BD59-A6C34878D82A}">
                    <a16:rowId xmlns:a16="http://schemas.microsoft.com/office/drawing/2014/main" val="4075261793"/>
                  </a:ext>
                </a:extLst>
              </a:tr>
              <a:tr h="380928">
                <a:tc>
                  <a:txBody>
                    <a:bodyPr/>
                    <a:lstStyle/>
                    <a:p>
                      <a:r>
                        <a:rPr lang="en-US" sz="1100" dirty="0"/>
                        <a:t>HCV Ab w/ reflex to PCR VL</a:t>
                      </a:r>
                    </a:p>
                  </a:txBody>
                  <a:tcPr marL="56968" marR="56968" marT="28484" marB="28484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All adults at least once</a:t>
                      </a:r>
                    </a:p>
                    <a:p>
                      <a:r>
                        <a:rPr lang="en-US" sz="1100" dirty="0"/>
                        <a:t>Annually for all MSM with HIV</a:t>
                      </a:r>
                    </a:p>
                  </a:txBody>
                  <a:tcPr marL="56968" marR="56968" marT="28484" marB="28484"/>
                </a:tc>
                <a:extLst>
                  <a:ext uri="{0D108BD9-81ED-4DB2-BD59-A6C34878D82A}">
                    <a16:rowId xmlns:a16="http://schemas.microsoft.com/office/drawing/2014/main" val="3074642861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931D76B5-FDB0-9E40-894F-A67BC37D8C27}"/>
              </a:ext>
            </a:extLst>
          </p:cNvPr>
          <p:cNvSpPr txBox="1"/>
          <p:nvPr/>
        </p:nvSpPr>
        <p:spPr>
          <a:xfrm>
            <a:off x="159548" y="2567157"/>
            <a:ext cx="4035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Helvetica" pitchFamily="2" charset="0"/>
              </a:rPr>
              <a:t>The 7 p’s of a sexual history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FB70A08-6A52-C342-A5DF-8BBA4AD1BCD1}"/>
              </a:ext>
            </a:extLst>
          </p:cNvPr>
          <p:cNvSpPr txBox="1"/>
          <p:nvPr/>
        </p:nvSpPr>
        <p:spPr>
          <a:xfrm>
            <a:off x="159549" y="585692"/>
            <a:ext cx="40350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Helvetica" pitchFamily="2" charset="0"/>
              </a:rPr>
              <a:t>Definition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FEFA882-D347-AA41-AF4A-D4BBD948FF81}"/>
              </a:ext>
            </a:extLst>
          </p:cNvPr>
          <p:cNvSpPr txBox="1"/>
          <p:nvPr/>
        </p:nvSpPr>
        <p:spPr>
          <a:xfrm>
            <a:off x="159548" y="5577054"/>
            <a:ext cx="40350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Helvetica" pitchFamily="2" charset="0"/>
              </a:rPr>
              <a:t>STI screening tests and indications*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9CFEDA9B-1A8F-3348-8920-8CB38ED25876}"/>
              </a:ext>
            </a:extLst>
          </p:cNvPr>
          <p:cNvCxnSpPr>
            <a:cxnSpLocks/>
          </p:cNvCxnSpPr>
          <p:nvPr/>
        </p:nvCxnSpPr>
        <p:spPr>
          <a:xfrm>
            <a:off x="4352081" y="601884"/>
            <a:ext cx="0" cy="9482686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3CD9A08E-B600-104F-AB99-042ADEC9C9B5}"/>
              </a:ext>
            </a:extLst>
          </p:cNvPr>
          <p:cNvCxnSpPr/>
          <p:nvPr/>
        </p:nvCxnSpPr>
        <p:spPr>
          <a:xfrm>
            <a:off x="0" y="601884"/>
            <a:ext cx="77724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741C4482-C3DF-334C-AD8E-0B54CBCC4768}"/>
              </a:ext>
            </a:extLst>
          </p:cNvPr>
          <p:cNvSpPr txBox="1"/>
          <p:nvPr/>
        </p:nvSpPr>
        <p:spPr>
          <a:xfrm>
            <a:off x="5197033" y="9853738"/>
            <a:ext cx="25753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V1, 01/2022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DA6C1CA5-2253-5E45-930D-9D8D3530C2CF}"/>
              </a:ext>
            </a:extLst>
          </p:cNvPr>
          <p:cNvCxnSpPr>
            <a:cxnSpLocks/>
          </p:cNvCxnSpPr>
          <p:nvPr/>
        </p:nvCxnSpPr>
        <p:spPr>
          <a:xfrm>
            <a:off x="-1" y="2554630"/>
            <a:ext cx="435208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29373E50-E556-9E4A-B6AE-5993AA2380F6}"/>
              </a:ext>
            </a:extLst>
          </p:cNvPr>
          <p:cNvCxnSpPr>
            <a:cxnSpLocks/>
          </p:cNvCxnSpPr>
          <p:nvPr/>
        </p:nvCxnSpPr>
        <p:spPr>
          <a:xfrm>
            <a:off x="0" y="5563405"/>
            <a:ext cx="435208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CCA45769-072A-DE47-AA2B-035C993AC4E4}"/>
              </a:ext>
            </a:extLst>
          </p:cNvPr>
          <p:cNvSpPr txBox="1"/>
          <p:nvPr/>
        </p:nvSpPr>
        <p:spPr>
          <a:xfrm>
            <a:off x="159548" y="8182168"/>
            <a:ext cx="4035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*Offer to all patients. Retest after new exposure and w/ high-risk behaviors. </a:t>
            </a:r>
            <a:endParaRPr lang="en-US" sz="900" u="sng" dirty="0"/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EAFFC336-50BD-094D-A9F6-FD3EB5C08CD7}"/>
              </a:ext>
            </a:extLst>
          </p:cNvPr>
          <p:cNvCxnSpPr>
            <a:cxnSpLocks/>
          </p:cNvCxnSpPr>
          <p:nvPr/>
        </p:nvCxnSpPr>
        <p:spPr>
          <a:xfrm>
            <a:off x="4352078" y="8987396"/>
            <a:ext cx="3420321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1F160A1F-A452-514C-8DFD-6D12DF0027A3}"/>
              </a:ext>
            </a:extLst>
          </p:cNvPr>
          <p:cNvSpPr txBox="1"/>
          <p:nvPr/>
        </p:nvSpPr>
        <p:spPr>
          <a:xfrm>
            <a:off x="4325024" y="8975141"/>
            <a:ext cx="342032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I: sexually transmitted illness; PrEP: pre-exposure prophylaxis; MSM: men who have sex with men; IVDU: IV drug use; TDF: Tenofovir Disoproxil Fumarate; TAF: Tenofovir Alafenamide; FTC: Emtricitabine.</a:t>
            </a: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or updated resources, please visit the CDC website on STI screening and treatment, and the CDC website for PrEP guidelines 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931B97E-1429-BD4A-89A5-9F01C587F591}"/>
              </a:ext>
            </a:extLst>
          </p:cNvPr>
          <p:cNvSpPr txBox="1"/>
          <p:nvPr/>
        </p:nvSpPr>
        <p:spPr>
          <a:xfrm>
            <a:off x="4352077" y="671474"/>
            <a:ext cx="34203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Helvetica" pitchFamily="2" charset="0"/>
              </a:rPr>
              <a:t>Pre-exposure prophylaxis (PrEP)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E35EF91-9E49-BF4F-8F9B-4F562916D9A7}"/>
              </a:ext>
            </a:extLst>
          </p:cNvPr>
          <p:cNvSpPr txBox="1"/>
          <p:nvPr/>
        </p:nvSpPr>
        <p:spPr>
          <a:xfrm>
            <a:off x="370730" y="8386769"/>
            <a:ext cx="1477793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b="1" dirty="0">
                <a:latin typeface="Helvetica" pitchFamily="2" charset="0"/>
              </a:rPr>
              <a:t>Rectal/throat swab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5F9181E-EE49-A643-8BC8-665616D45C5A}"/>
              </a:ext>
            </a:extLst>
          </p:cNvPr>
          <p:cNvSpPr txBox="1"/>
          <p:nvPr/>
        </p:nvSpPr>
        <p:spPr>
          <a:xfrm>
            <a:off x="2115225" y="8386769"/>
            <a:ext cx="2041772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b="1" dirty="0">
                <a:latin typeface="Helvetica" pitchFamily="2" charset="0"/>
              </a:rPr>
              <a:t>Endocervical/vaginal swab</a:t>
            </a:r>
          </a:p>
        </p:txBody>
      </p:sp>
      <p:pic>
        <p:nvPicPr>
          <p:cNvPr id="9" name="Graphic 8" descr="Kidneys outline">
            <a:extLst>
              <a:ext uri="{FF2B5EF4-FFF2-40B4-BE49-F238E27FC236}">
                <a16:creationId xmlns:a16="http://schemas.microsoft.com/office/drawing/2014/main" id="{3F3A57EF-4BEC-4549-A563-F2830DF142A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4662378" y="6661600"/>
            <a:ext cx="457200" cy="457200"/>
          </a:xfrm>
          <a:prstGeom prst="rect">
            <a:avLst/>
          </a:prstGeom>
        </p:spPr>
      </p:pic>
      <p:pic>
        <p:nvPicPr>
          <p:cNvPr id="16" name="Graphic 15" descr="Bone outline">
            <a:extLst>
              <a:ext uri="{FF2B5EF4-FFF2-40B4-BE49-F238E27FC236}">
                <a16:creationId xmlns:a16="http://schemas.microsoft.com/office/drawing/2014/main" id="{45167E14-6F01-AD4D-B527-A6A2C7E70C3E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5141899" y="6661600"/>
            <a:ext cx="457200" cy="457200"/>
          </a:xfrm>
          <a:prstGeom prst="rect">
            <a:avLst/>
          </a:prstGeom>
        </p:spPr>
      </p:pic>
      <p:sp>
        <p:nvSpPr>
          <p:cNvPr id="21" name="Curved Right Arrow 20">
            <a:extLst>
              <a:ext uri="{FF2B5EF4-FFF2-40B4-BE49-F238E27FC236}">
                <a16:creationId xmlns:a16="http://schemas.microsoft.com/office/drawing/2014/main" id="{FAC2704E-8BA5-2449-9075-37B6A4C406BB}"/>
              </a:ext>
            </a:extLst>
          </p:cNvPr>
          <p:cNvSpPr/>
          <p:nvPr/>
        </p:nvSpPr>
        <p:spPr>
          <a:xfrm rot="21424160">
            <a:off x="4123796" y="5476225"/>
            <a:ext cx="444789" cy="1559074"/>
          </a:xfrm>
          <a:prstGeom prst="curvedRightArrow">
            <a:avLst/>
          </a:prstGeom>
          <a:solidFill>
            <a:srgbClr val="F4B3FD"/>
          </a:solidFill>
          <a:ln>
            <a:solidFill>
              <a:srgbClr val="F4B3F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35" name="Curved Right Arrow 34">
            <a:extLst>
              <a:ext uri="{FF2B5EF4-FFF2-40B4-BE49-F238E27FC236}">
                <a16:creationId xmlns:a16="http://schemas.microsoft.com/office/drawing/2014/main" id="{AE297C37-09F9-F64E-9DBA-2E522E924970}"/>
              </a:ext>
            </a:extLst>
          </p:cNvPr>
          <p:cNvSpPr/>
          <p:nvPr/>
        </p:nvSpPr>
        <p:spPr>
          <a:xfrm rot="19421296" flipH="1">
            <a:off x="7084564" y="5554330"/>
            <a:ext cx="511823" cy="1299387"/>
          </a:xfrm>
          <a:prstGeom prst="curvedRightArrow">
            <a:avLst>
              <a:gd name="adj1" fmla="val 25000"/>
              <a:gd name="adj2" fmla="val 50000"/>
              <a:gd name="adj3" fmla="val 28397"/>
            </a:avLst>
          </a:prstGeom>
          <a:solidFill>
            <a:srgbClr val="6481DF"/>
          </a:solidFill>
          <a:ln>
            <a:solidFill>
              <a:srgbClr val="6481D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pic>
        <p:nvPicPr>
          <p:cNvPr id="3" name="Graphic 2" descr="No sign with solid fill">
            <a:extLst>
              <a:ext uri="{FF2B5EF4-FFF2-40B4-BE49-F238E27FC236}">
                <a16:creationId xmlns:a16="http://schemas.microsoft.com/office/drawing/2014/main" id="{BB9F3A07-E093-C341-933A-911217C6F85E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4516835" y="4519482"/>
            <a:ext cx="371924" cy="37192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AA5BC2F-8E52-0C48-ADB8-D9523795508B}"/>
              </a:ext>
            </a:extLst>
          </p:cNvPr>
          <p:cNvSpPr txBox="1"/>
          <p:nvPr/>
        </p:nvSpPr>
        <p:spPr>
          <a:xfrm>
            <a:off x="4835211" y="4487812"/>
            <a:ext cx="95246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C00000"/>
                </a:solidFill>
              </a:rPr>
              <a:t>If CrCl &lt;60:</a:t>
            </a:r>
          </a:p>
          <a:p>
            <a:r>
              <a:rPr lang="en-US" sz="1200" dirty="0">
                <a:solidFill>
                  <a:srgbClr val="C00000"/>
                </a:solidFill>
              </a:rPr>
              <a:t>No Truvad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D57B21C-0AB3-F748-83D7-FE5DB03D8AF7}"/>
              </a:ext>
            </a:extLst>
          </p:cNvPr>
          <p:cNvSpPr txBox="1"/>
          <p:nvPr/>
        </p:nvSpPr>
        <p:spPr>
          <a:xfrm>
            <a:off x="6339988" y="4430203"/>
            <a:ext cx="140053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C00000"/>
                </a:solidFill>
              </a:rPr>
              <a:t>If HBV, hold </a:t>
            </a:r>
          </a:p>
          <a:p>
            <a:r>
              <a:rPr lang="en-US" sz="1200" dirty="0">
                <a:solidFill>
                  <a:srgbClr val="C00000"/>
                </a:solidFill>
              </a:rPr>
              <a:t>PrEP and </a:t>
            </a:r>
          </a:p>
          <a:p>
            <a:r>
              <a:rPr lang="en-US" sz="1200" dirty="0">
                <a:solidFill>
                  <a:srgbClr val="C00000"/>
                </a:solidFill>
              </a:rPr>
              <a:t>treat HBV first</a:t>
            </a:r>
          </a:p>
        </p:txBody>
      </p:sp>
      <p:pic>
        <p:nvPicPr>
          <p:cNvPr id="37" name="Graphic 36" descr="No sign with solid fill">
            <a:extLst>
              <a:ext uri="{FF2B5EF4-FFF2-40B4-BE49-F238E27FC236}">
                <a16:creationId xmlns:a16="http://schemas.microsoft.com/office/drawing/2014/main" id="{45553DC2-80A6-1D48-A3B0-FC74CF181491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7304663" y="4519482"/>
            <a:ext cx="371924" cy="371924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52C59296-1BFD-5B4B-8FF3-7411AB354A33}"/>
              </a:ext>
            </a:extLst>
          </p:cNvPr>
          <p:cNvSpPr txBox="1"/>
          <p:nvPr/>
        </p:nvSpPr>
        <p:spPr>
          <a:xfrm>
            <a:off x="7028816" y="6796471"/>
            <a:ext cx="5070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LDL</a:t>
            </a:r>
          </a:p>
        </p:txBody>
      </p:sp>
      <p:pic>
        <p:nvPicPr>
          <p:cNvPr id="39" name="Picture 38" descr="Icon&#10;&#10;Description automatically generated">
            <a:extLst>
              <a:ext uri="{FF2B5EF4-FFF2-40B4-BE49-F238E27FC236}">
                <a16:creationId xmlns:a16="http://schemas.microsoft.com/office/drawing/2014/main" id="{DAC37573-2365-BC40-BD83-9B6CBB414F49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21324" t="14084" r="19848" b="16346"/>
          <a:stretch/>
        </p:blipFill>
        <p:spPr>
          <a:xfrm>
            <a:off x="6597688" y="6640577"/>
            <a:ext cx="411499" cy="486650"/>
          </a:xfrm>
          <a:prstGeom prst="rect">
            <a:avLst/>
          </a:prstGeom>
          <a:solidFill>
            <a:srgbClr val="6481DF"/>
          </a:solidFill>
        </p:spPr>
      </p:pic>
      <p:pic>
        <p:nvPicPr>
          <p:cNvPr id="44" name="Graphic 43" descr="Water outline">
            <a:extLst>
              <a:ext uri="{FF2B5EF4-FFF2-40B4-BE49-F238E27FC236}">
                <a16:creationId xmlns:a16="http://schemas.microsoft.com/office/drawing/2014/main" id="{F84ED475-3693-9A40-9F45-7A4DC006C613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96DAC541-7B7A-43D3-8B79-37D633B846F1}">
                <asvg:svgBlip xmlns:asvg="http://schemas.microsoft.com/office/drawing/2016/SVG/main" r:embed="rId16"/>
              </a:ext>
            </a:extLst>
          </a:blip>
          <a:stretch>
            <a:fillRect/>
          </a:stretch>
        </p:blipFill>
        <p:spPr>
          <a:xfrm>
            <a:off x="6992672" y="6612423"/>
            <a:ext cx="579375" cy="579375"/>
          </a:xfrm>
          <a:prstGeom prst="rect">
            <a:avLst/>
          </a:prstGeom>
        </p:spPr>
      </p:pic>
      <p:sp>
        <p:nvSpPr>
          <p:cNvPr id="50" name="Rectangle 49">
            <a:extLst>
              <a:ext uri="{FF2B5EF4-FFF2-40B4-BE49-F238E27FC236}">
                <a16:creationId xmlns:a16="http://schemas.microsoft.com/office/drawing/2014/main" id="{B8EC2E0D-B110-9D4C-A624-E23352DFB8A8}"/>
              </a:ext>
            </a:extLst>
          </p:cNvPr>
          <p:cNvSpPr/>
          <p:nvPr/>
        </p:nvSpPr>
        <p:spPr>
          <a:xfrm>
            <a:off x="1933484" y="9552371"/>
            <a:ext cx="2261083" cy="389157"/>
          </a:xfrm>
          <a:prstGeom prst="rect">
            <a:avLst/>
          </a:prstGeom>
          <a:solidFill>
            <a:srgbClr val="FFE8CB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900" b="1" dirty="0">
                <a:solidFill>
                  <a:schemeClr val="tx1"/>
                </a:solidFill>
              </a:rPr>
              <a:t>Gonorrhea</a:t>
            </a:r>
            <a:r>
              <a:rPr lang="en-US" sz="900" dirty="0">
                <a:solidFill>
                  <a:schemeClr val="tx1"/>
                </a:solidFill>
              </a:rPr>
              <a:t>: Ceftriaxone 500 mg IM x1 dose</a:t>
            </a:r>
          </a:p>
          <a:p>
            <a:r>
              <a:rPr lang="en-US" sz="900" b="1" dirty="0">
                <a:solidFill>
                  <a:schemeClr val="tx1"/>
                </a:solidFill>
              </a:rPr>
              <a:t>Chlamydia</a:t>
            </a:r>
            <a:r>
              <a:rPr lang="en-US" sz="900" dirty="0">
                <a:solidFill>
                  <a:schemeClr val="tx1"/>
                </a:solidFill>
              </a:rPr>
              <a:t>: Doxycycline 100 mg BID x7days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2A4E0828-3ADA-F846-ACF7-B966DFACDE66}"/>
              </a:ext>
            </a:extLst>
          </p:cNvPr>
          <p:cNvSpPr/>
          <p:nvPr/>
        </p:nvSpPr>
        <p:spPr>
          <a:xfrm>
            <a:off x="-371633" y="9684461"/>
            <a:ext cx="147779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u="sng" dirty="0"/>
              <a:t>Swabs may </a:t>
            </a:r>
          </a:p>
          <a:p>
            <a:pPr algn="ctr"/>
            <a:r>
              <a:rPr lang="en-US" sz="800" u="sng" dirty="0"/>
              <a:t>vary by clinic</a:t>
            </a:r>
            <a:endParaRPr lang="en-US" sz="8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0A22531-6DB0-E422-3438-3D01DC75F204}"/>
              </a:ext>
            </a:extLst>
          </p:cNvPr>
          <p:cNvSpPr txBox="1"/>
          <p:nvPr/>
        </p:nvSpPr>
        <p:spPr>
          <a:xfrm>
            <a:off x="487014" y="8705023"/>
            <a:ext cx="1238288" cy="7386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endParaRPr lang="en-US" sz="1400" dirty="0"/>
          </a:p>
          <a:p>
            <a:r>
              <a:rPr lang="en-US" sz="1400" dirty="0"/>
              <a:t>Image of swab</a:t>
            </a:r>
          </a:p>
          <a:p>
            <a:endParaRPr lang="en-US" sz="14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89DFACC-1BC4-B7DB-8698-7B4D2DC01EA1}"/>
              </a:ext>
            </a:extLst>
          </p:cNvPr>
          <p:cNvSpPr txBox="1"/>
          <p:nvPr/>
        </p:nvSpPr>
        <p:spPr>
          <a:xfrm>
            <a:off x="2516967" y="8705023"/>
            <a:ext cx="1238288" cy="7386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endParaRPr lang="en-US" sz="1400" dirty="0"/>
          </a:p>
          <a:p>
            <a:r>
              <a:rPr lang="en-US" sz="1400" dirty="0"/>
              <a:t>Image of swab</a:t>
            </a:r>
          </a:p>
          <a:p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9498666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03</TotalTime>
  <Words>682</Words>
  <Application>Microsoft Macintosh PowerPoint</Application>
  <PresentationFormat>Custom</PresentationFormat>
  <Paragraphs>8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bastian Suarez</dc:creator>
  <cp:lastModifiedBy>Sebastian Suarez</cp:lastModifiedBy>
  <cp:revision>26</cp:revision>
  <dcterms:created xsi:type="dcterms:W3CDTF">2022-01-10T18:53:26Z</dcterms:created>
  <dcterms:modified xsi:type="dcterms:W3CDTF">2024-07-23T02:12:16Z</dcterms:modified>
</cp:coreProperties>
</file>